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8" r:id="rId2"/>
  </p:sldIdLst>
  <p:sldSz cx="9144000" cy="6858000" type="screen4x3"/>
  <p:notesSz cx="6858000" cy="9144000"/>
  <p:defaultTextStyle>
    <a:defPPr>
      <a:defRPr lang="vi-V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9" autoAdjust="0"/>
    <p:restoredTop sz="94660"/>
  </p:normalViewPr>
  <p:slideViewPr>
    <p:cSldViewPr snapToGrid="0" showGuides="1">
      <p:cViewPr varScale="1">
        <p:scale>
          <a:sx n="112" d="100"/>
          <a:sy n="112" d="100"/>
        </p:scale>
        <p:origin x="1422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클릭하여 마스터 부제목 스타일 편집</a:t>
            </a:r>
            <a:endParaRPr lang="vi-V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750A5A-F4A0-4667-BE4B-DC860058EF8E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CCFAF4F-25DB-41D8-BF24-45921BAF7BDA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5E535E-BF59-4F25-863A-11316EF0E704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0957102-B2EF-4F23-9F18-0DA6ECB02789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A3FDC0-F712-4760-9084-3CA042AF39D5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EB9D2BD-4A6F-4824-B187-2AF02786FC83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1AB3A8-4A99-417B-9187-223D70D93153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CB40EF8-2660-4DC5-AB0D-E57906810078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FB2658-7FB1-455F-A28B-6086F4064325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3E191B3-3AD5-45BF-8D11-CAF7195C216E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A55F12-D892-44BF-9057-584DB09B0086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255E60F-7785-40C3-9141-657B9706660F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BB0935-011C-460C-B3E5-D90402EFBA77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2945FC1-53BC-4FB7-ADCF-389E7BE19C73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E8396C-43FC-48F0-B7D5-1419620710B9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F5C207B-A4F2-4460-82D4-A57E3277B5F1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3ADB25-5DB0-4BF5-BEC0-F1AAAB573B97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05BDECF-B52B-45F8-82B3-0A470B551A6D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884F75-D622-4318-99F4-104703804238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D4AF779-CEF4-4698-A74E-9A251D2A9355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ko-KR" altLang="en-US" noProof="0"/>
              <a:t>그림을 추가하려면 아이콘을 클릭하십시오</a:t>
            </a:r>
            <a:endParaRPr lang="vi-VN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31DE9EC-D341-467D-A37D-F579B455FE58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6946282-70B4-49EF-9014-DCBDC00AD1E0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/>
              <a:t>마스터 제목 스타일 편집</a:t>
            </a:r>
            <a:endParaRPr lang="vi-VN" altLang="fr-FR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 altLang="fr-F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9B3AF6E1-342C-4CA0-94FB-BE06805466BB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latin typeface="Arial" charset="0"/>
              </a:defRPr>
            </a:lvl1pPr>
          </a:lstStyle>
          <a:p>
            <a:fld id="{19BBFF9C-B948-4F3B-B72B-E4282A166359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1" fontAlgn="base" latinLnBrk="1" hangingPunct="1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1" fontAlgn="base" latinLnBrk="1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</a:defRPr>
      </a:lvl2pPr>
      <a:lvl3pPr algn="ctr" rtl="0" eaLnBrk="1" fontAlgn="base" latinLnBrk="1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</a:defRPr>
      </a:lvl3pPr>
      <a:lvl4pPr algn="ctr" rtl="0" eaLnBrk="1" fontAlgn="base" latinLnBrk="1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</a:defRPr>
      </a:lvl4pPr>
      <a:lvl5pPr algn="ctr" rtl="0" eaLnBrk="1" fontAlgn="base" latinLnBrk="1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</a:defRPr>
      </a:lvl5pPr>
      <a:lvl6pPr marL="457200" algn="ctr" rtl="0" eaLnBrk="1" fontAlgn="base" latinLnBrk="1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</a:defRPr>
      </a:lvl6pPr>
      <a:lvl7pPr marL="914400" algn="ctr" rtl="0" eaLnBrk="1" fontAlgn="base" latinLnBrk="1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</a:defRPr>
      </a:lvl7pPr>
      <a:lvl8pPr marL="1371600" algn="ctr" rtl="0" eaLnBrk="1" fontAlgn="base" latinLnBrk="1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</a:defRPr>
      </a:lvl8pPr>
      <a:lvl9pPr marL="1828800" algn="ctr" rtl="0" eaLnBrk="1" fontAlgn="base" latinLnBrk="1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</a:defRPr>
      </a:lvl9pPr>
    </p:titleStyle>
    <p:bodyStyle>
      <a:lvl1pPr marL="342900" indent="-342900" algn="l" rtl="0" eaLnBrk="1" fontAlgn="base" latinLnBrk="1" hangingPunct="1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1" fontAlgn="base" latinLnBrk="1" hangingPunct="1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1" fontAlgn="base" latinLnBrk="1" hangingPunct="1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1" fontAlgn="base" latinLnBrk="1" hangingPunct="1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1" fontAlgn="base" latinLnBrk="1" hangingPunct="1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vi-VN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3C5B5821-45A3-45EC-A425-720A6572D713}"/>
              </a:ext>
            </a:extLst>
          </p:cNvPr>
          <p:cNvGrpSpPr/>
          <p:nvPr/>
        </p:nvGrpSpPr>
        <p:grpSpPr>
          <a:xfrm>
            <a:off x="288128" y="0"/>
            <a:ext cx="8567744" cy="5882668"/>
            <a:chOff x="275558" y="75503"/>
            <a:chExt cx="8567744" cy="5882668"/>
          </a:xfrm>
        </p:grpSpPr>
        <p:grpSp>
          <p:nvGrpSpPr>
            <p:cNvPr id="22" name="그룹 21">
              <a:extLst>
                <a:ext uri="{FF2B5EF4-FFF2-40B4-BE49-F238E27FC236}">
                  <a16:creationId xmlns:a16="http://schemas.microsoft.com/office/drawing/2014/main" id="{917FB578-01D9-4F1D-A7A6-A47484F93FAC}"/>
                </a:ext>
              </a:extLst>
            </p:cNvPr>
            <p:cNvGrpSpPr/>
            <p:nvPr/>
          </p:nvGrpSpPr>
          <p:grpSpPr>
            <a:xfrm>
              <a:off x="1769667" y="359439"/>
              <a:ext cx="7073635" cy="5598732"/>
              <a:chOff x="1769667" y="359439"/>
              <a:chExt cx="7073635" cy="5598732"/>
            </a:xfrm>
          </p:grpSpPr>
          <p:pic>
            <p:nvPicPr>
              <p:cNvPr id="4" name="그림 3">
                <a:extLst>
                  <a:ext uri="{FF2B5EF4-FFF2-40B4-BE49-F238E27FC236}">
                    <a16:creationId xmlns:a16="http://schemas.microsoft.com/office/drawing/2014/main" id="{74EA8619-19BC-486F-9D87-15FF9093FF3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8441" t="19725" r="36059" b="2275"/>
              <a:stretch/>
            </p:blipFill>
            <p:spPr>
              <a:xfrm>
                <a:off x="3148233" y="359439"/>
                <a:ext cx="2847536" cy="2644140"/>
              </a:xfrm>
              <a:prstGeom prst="rect">
                <a:avLst/>
              </a:prstGeom>
            </p:spPr>
          </p:pic>
          <p:pic>
            <p:nvPicPr>
              <p:cNvPr id="16" name="그림 15">
                <a:extLst>
                  <a:ext uri="{FF2B5EF4-FFF2-40B4-BE49-F238E27FC236}">
                    <a16:creationId xmlns:a16="http://schemas.microsoft.com/office/drawing/2014/main" id="{1344C240-3768-4D9A-BAB9-822E6A49DE2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8441" t="19894" r="36059" b="2106"/>
              <a:stretch/>
            </p:blipFill>
            <p:spPr>
              <a:xfrm>
                <a:off x="5995767" y="359439"/>
                <a:ext cx="2847535" cy="2644140"/>
              </a:xfrm>
              <a:prstGeom prst="rect">
                <a:avLst/>
              </a:prstGeom>
            </p:spPr>
          </p:pic>
          <p:pic>
            <p:nvPicPr>
              <p:cNvPr id="17" name="그림 16">
                <a:extLst>
                  <a:ext uri="{FF2B5EF4-FFF2-40B4-BE49-F238E27FC236}">
                    <a16:creationId xmlns:a16="http://schemas.microsoft.com/office/drawing/2014/main" id="{0B322C1A-3A7C-4B69-817C-6ED2B7CE487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18373" t="19770" r="36127" b="2230"/>
              <a:stretch/>
            </p:blipFill>
            <p:spPr>
              <a:xfrm>
                <a:off x="1769667" y="3314031"/>
                <a:ext cx="2847536" cy="2644140"/>
              </a:xfrm>
              <a:prstGeom prst="rect">
                <a:avLst/>
              </a:prstGeom>
            </p:spPr>
          </p:pic>
        </p:grpSp>
        <p:pic>
          <p:nvPicPr>
            <p:cNvPr id="18" name="그림 17">
              <a:extLst>
                <a:ext uri="{FF2B5EF4-FFF2-40B4-BE49-F238E27FC236}">
                  <a16:creationId xmlns:a16="http://schemas.microsoft.com/office/drawing/2014/main" id="{36277293-082E-4936-A3BA-7DE66AC4FB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8333" t="20193" r="36167" b="1808"/>
            <a:stretch/>
          </p:blipFill>
          <p:spPr>
            <a:xfrm>
              <a:off x="4617203" y="3314031"/>
              <a:ext cx="2847535" cy="2644140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90E1BB2-EC25-46E1-B53E-1043241350CD}"/>
                </a:ext>
              </a:extLst>
            </p:cNvPr>
            <p:cNvSpPr txBox="1"/>
            <p:nvPr/>
          </p:nvSpPr>
          <p:spPr>
            <a:xfrm>
              <a:off x="345909" y="75503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8AB9D40C-FB2F-4D19-BD22-5723F6C5CFE1}"/>
                </a:ext>
              </a:extLst>
            </p:cNvPr>
            <p:cNvSpPr txBox="1"/>
            <p:nvPr/>
          </p:nvSpPr>
          <p:spPr>
            <a:xfrm>
              <a:off x="3193440" y="75503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77EFE788-5930-4F40-B806-3F11075FFA84}"/>
                </a:ext>
              </a:extLst>
            </p:cNvPr>
            <p:cNvSpPr txBox="1"/>
            <p:nvPr/>
          </p:nvSpPr>
          <p:spPr>
            <a:xfrm>
              <a:off x="6040971" y="75503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25C02C30-E08E-4C94-B762-E1463C6F483B}"/>
                </a:ext>
              </a:extLst>
            </p:cNvPr>
            <p:cNvSpPr txBox="1"/>
            <p:nvPr/>
          </p:nvSpPr>
          <p:spPr>
            <a:xfrm>
              <a:off x="4662411" y="3003579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E</a:t>
              </a:r>
            </a:p>
          </p:txBody>
        </p:sp>
        <p:pic>
          <p:nvPicPr>
            <p:cNvPr id="20" name="그림 19">
              <a:extLst>
                <a:ext uri="{FF2B5EF4-FFF2-40B4-BE49-F238E27FC236}">
                  <a16:creationId xmlns:a16="http://schemas.microsoft.com/office/drawing/2014/main" id="{384966D6-556E-47A0-95AB-B24E1686F23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8417" t="19693" r="36083" b="2308"/>
            <a:stretch/>
          </p:blipFill>
          <p:spPr>
            <a:xfrm>
              <a:off x="275558" y="359439"/>
              <a:ext cx="2850072" cy="2646495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F1A81F75-261D-49A0-972B-49513CDA81A5}"/>
                </a:ext>
              </a:extLst>
            </p:cNvPr>
            <p:cNvSpPr txBox="1"/>
            <p:nvPr/>
          </p:nvSpPr>
          <p:spPr>
            <a:xfrm>
              <a:off x="1814880" y="3003579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D</a:t>
              </a: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1CAD0B81-107C-4E0C-9DAB-B11C1535114C}"/>
              </a:ext>
            </a:extLst>
          </p:cNvPr>
          <p:cNvSpPr txBox="1"/>
          <p:nvPr/>
        </p:nvSpPr>
        <p:spPr>
          <a:xfrm>
            <a:off x="115374" y="5915152"/>
            <a:ext cx="923468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1"/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ncipal component analysis (PCA) 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the 223 cultivated pumpkin accessions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ing 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192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, 96 (B), 48 (C), 24 (D), and 12 (E) 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rkers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color codes indicate 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maxima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lue), 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altLang="ko-KR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schata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ed), </a:t>
            </a:r>
            <a:r>
              <a:rPr lang="en-US" altLang="ko-KR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maxima 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altLang="ko-KR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altLang="ko-KR" sz="16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schata</a:t>
            </a:r>
            <a:r>
              <a:rPr lang="en-US" altLang="ko-KR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brid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orange), 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pepo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reen), and unknown (gray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cessions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698477"/>
      </p:ext>
    </p:extLst>
  </p:cSld>
  <p:clrMapOvr>
    <a:masterClrMapping/>
  </p:clrMapOvr>
</p:sld>
</file>

<file path=ppt/theme/theme1.xml><?xml version="1.0" encoding="utf-8"?>
<a:theme xmlns:a="http://schemas.openxmlformats.org/drawingml/2006/main" name="theme 1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theme 1" id="{EDB62F8C-0C32-44F6-998E-439F59C6F9FB}" vid="{46AF7F10-F817-4C45-80B1-D634AB534084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8</TotalTime>
  <Words>85</Words>
  <Application>Microsoft Office PowerPoint</Application>
  <PresentationFormat>화면 슬라이드 쇼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Times New Roman</vt:lpstr>
      <vt:lpstr>theme 1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민경</dc:creator>
  <cp:lastModifiedBy>user1018</cp:lastModifiedBy>
  <cp:revision>6</cp:revision>
  <dcterms:created xsi:type="dcterms:W3CDTF">2020-03-06T10:28:00Z</dcterms:created>
  <dcterms:modified xsi:type="dcterms:W3CDTF">2020-03-07T10:38:36Z</dcterms:modified>
</cp:coreProperties>
</file>